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44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655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387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828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461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470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32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25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563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772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045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607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23A83-0B19-4C5D-94CE-E08FC1DB5C7A}" type="datetimeFigureOut">
              <a:rPr lang="en-US" smtClean="0"/>
              <a:t>1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D9CC3-020B-448C-B22F-CE68133CF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589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F534C0C-9EDE-BCF2-5C3F-0E02905113C2}"/>
              </a:ext>
            </a:extLst>
          </p:cNvPr>
          <p:cNvGrpSpPr/>
          <p:nvPr/>
        </p:nvGrpSpPr>
        <p:grpSpPr>
          <a:xfrm>
            <a:off x="1295400" y="401983"/>
            <a:ext cx="4272888" cy="7680960"/>
            <a:chOff x="1295400" y="401983"/>
            <a:chExt cx="4272888" cy="768096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BFCC2B0-6162-D0DF-09EA-2138E110A20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5400" y="401983"/>
              <a:ext cx="4267199" cy="256032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3B61D07-C2E1-B939-3F08-EF468923980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01089" y="2962303"/>
              <a:ext cx="4261510" cy="256032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EC68F2F-6847-CE9E-03CE-FDEC20F262B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06778" y="5522623"/>
              <a:ext cx="4261510" cy="2560320"/>
            </a:xfrm>
            <a:prstGeom prst="rect">
              <a:avLst/>
            </a:prstGeom>
          </p:spPr>
        </p:pic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F10ADAE6-7B33-2619-2224-A472BC317296}"/>
              </a:ext>
            </a:extLst>
          </p:cNvPr>
          <p:cNvSpPr txBox="1"/>
          <p:nvPr/>
        </p:nvSpPr>
        <p:spPr>
          <a:xfrm>
            <a:off x="263114" y="8082943"/>
            <a:ext cx="644769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6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pression level in ‘Granny Smith’ (white bar) and ‘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din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’ (grey bar) apple cultivars of genes related with lipids metabolism. The error bars correspond to the standard deviation. RA= Regular Atmosphere; 1-MCP= Regular Atmosphere + 1-MCP treatment; LO= Low Oxygen condition. FPKM= fragments per kilobase of transcript per million fragments mapped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DC5CA54-9F75-4E49-F850-BAAF770A9178}"/>
              </a:ext>
            </a:extLst>
          </p:cNvPr>
          <p:cNvSpPr txBox="1"/>
          <p:nvPr/>
        </p:nvSpPr>
        <p:spPr>
          <a:xfrm>
            <a:off x="228599" y="97038"/>
            <a:ext cx="1813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89"/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. Fig. 6</a:t>
            </a:r>
          </a:p>
        </p:txBody>
      </p:sp>
    </p:spTree>
    <p:extLst>
      <p:ext uri="{BB962C8B-B14F-4D97-AF65-F5344CB8AC3E}">
        <p14:creationId xmlns:p14="http://schemas.microsoft.com/office/powerpoint/2010/main" val="2694802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7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Fondazione Edmund Ma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opulin</dc:creator>
  <cp:lastModifiedBy>Francesca Populin</cp:lastModifiedBy>
  <cp:revision>8</cp:revision>
  <dcterms:created xsi:type="dcterms:W3CDTF">2022-06-20T08:37:06Z</dcterms:created>
  <dcterms:modified xsi:type="dcterms:W3CDTF">2023-01-12T07:36:23Z</dcterms:modified>
</cp:coreProperties>
</file>